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6.jpeg" ContentType="image/jpeg"/>
  <Override PartName="/ppt/media/image8.png" ContentType="image/png"/>
  <Override PartName="/ppt/media/image7.png" ContentType="image/png"/>
  <Override PartName="/ppt/media/image1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CF28F-86C9-4A46-BC92-481E486266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9E2AF-30AC-4A24-8634-E67222B992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41D02-79AD-4142-B7C6-5D33736B76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94B12-ED08-4A0D-9FE6-0E483439C0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7D3B0-FD8C-47A7-B6F0-4F9EB902FD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E4E74-5DD0-4903-9E36-5701A510EC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CCEE5A-5944-4B6A-84F3-EEA9B21FC3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CAA47-C4C4-4686-B641-8D205C4FB8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00A65-7B9A-4EE4-B805-743B50E432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49CA9-51CD-4259-A111-BC838F0699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580C1-1705-444B-B4E2-EA0A6892D5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AF15B-CABF-4B22-87DB-AA2DB5CDE6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41FECE-FD27-4F52-8422-51365A613AC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jpe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jpeg"/><Relationship Id="rId9" Type="http://schemas.openxmlformats.org/officeDocument/2006/relationships/image" Target="../media/image10.png"/><Relationship Id="rId10" Type="http://schemas.openxmlformats.org/officeDocument/2006/relationships/image" Target="../media/image11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>
            <a:lum bright="24000"/>
          </a:blip>
          <a:srcRect l="0" t="16821" r="15716" b="-1609"/>
          <a:stretch/>
        </p:blipFill>
        <p:spPr>
          <a:xfrm>
            <a:off x="2209680" y="1523880"/>
            <a:ext cx="4648320" cy="35053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04920" y="5545080"/>
            <a:ext cx="86868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For example, collect 1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µ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L of extracellular fluid from the surface of frozen bovine liver tissues stored at –20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°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C from a grocery store, place directly on a glass slide and observe the tubular cells under a light microscope. As the droplet dries, the existence of tubular structures and their connected networks are seen in time-lapse image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76920" y="380880"/>
            <a:ext cx="85809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宋体"/>
              </a:rPr>
              <a:t>The pre-existence of tubular cells from tissues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"/>
          <p:cNvGrpSpPr/>
          <p:nvPr/>
        </p:nvGrpSpPr>
        <p:grpSpPr>
          <a:xfrm>
            <a:off x="1781280" y="1311120"/>
            <a:ext cx="5533920" cy="4133520"/>
            <a:chOff x="1781280" y="1311120"/>
            <a:chExt cx="5533920" cy="4133520"/>
          </a:xfrm>
        </p:grpSpPr>
        <p:pic>
          <p:nvPicPr>
            <p:cNvPr id="45" name="" descr=""/>
            <p:cNvPicPr/>
            <p:nvPr/>
          </p:nvPicPr>
          <p:blipFill>
            <a:blip r:embed="rId1"/>
            <a:stretch/>
          </p:blipFill>
          <p:spPr>
            <a:xfrm>
              <a:off x="1781280" y="131112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6" name=""/>
            <p:cNvGrpSpPr/>
            <p:nvPr/>
          </p:nvGrpSpPr>
          <p:grpSpPr>
            <a:xfrm>
              <a:off x="6658920" y="5003640"/>
              <a:ext cx="609120" cy="366480"/>
              <a:chOff x="6658920" y="5003640"/>
              <a:chExt cx="609120" cy="366480"/>
            </a:xfrm>
          </p:grpSpPr>
          <p:grpSp>
            <p:nvGrpSpPr>
              <p:cNvPr id="47" name=""/>
              <p:cNvGrpSpPr/>
              <p:nvPr/>
            </p:nvGrpSpPr>
            <p:grpSpPr>
              <a:xfrm>
                <a:off x="6897600" y="5003640"/>
                <a:ext cx="152280" cy="75960"/>
                <a:chOff x="6897600" y="5003640"/>
                <a:chExt cx="152280" cy="75960"/>
              </a:xfrm>
            </p:grpSpPr>
            <p:sp>
              <p:nvSpPr>
                <p:cNvPr id="48" name=""/>
                <p:cNvSpPr/>
                <p:nvPr/>
              </p:nvSpPr>
              <p:spPr>
                <a:xfrm>
                  <a:off x="6897600" y="504144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7049880" y="500364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6897600" y="500364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1" name=""/>
              <p:cNvSpPr/>
              <p:nvPr/>
            </p:nvSpPr>
            <p:spPr>
              <a:xfrm>
                <a:off x="6658920" y="507816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2" name=""/>
          <p:cNvGrpSpPr/>
          <p:nvPr/>
        </p:nvGrpSpPr>
        <p:grpSpPr>
          <a:xfrm>
            <a:off x="1774800" y="1320840"/>
            <a:ext cx="5533920" cy="4133520"/>
            <a:chOff x="1774800" y="1320840"/>
            <a:chExt cx="5533920" cy="4133520"/>
          </a:xfrm>
        </p:grpSpPr>
        <p:pic>
          <p:nvPicPr>
            <p:cNvPr id="53" name="" descr=""/>
            <p:cNvPicPr/>
            <p:nvPr/>
          </p:nvPicPr>
          <p:blipFill>
            <a:blip r:embed="rId2"/>
            <a:stretch/>
          </p:blipFill>
          <p:spPr>
            <a:xfrm>
              <a:off x="1774800" y="132084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4" name=""/>
            <p:cNvGrpSpPr/>
            <p:nvPr/>
          </p:nvGrpSpPr>
          <p:grpSpPr>
            <a:xfrm>
              <a:off x="6652440" y="5013360"/>
              <a:ext cx="609120" cy="366480"/>
              <a:chOff x="6652440" y="5013360"/>
              <a:chExt cx="609120" cy="366480"/>
            </a:xfrm>
          </p:grpSpPr>
          <p:grpSp>
            <p:nvGrpSpPr>
              <p:cNvPr id="55" name=""/>
              <p:cNvGrpSpPr/>
              <p:nvPr/>
            </p:nvGrpSpPr>
            <p:grpSpPr>
              <a:xfrm>
                <a:off x="6891120" y="5013360"/>
                <a:ext cx="152280" cy="75960"/>
                <a:chOff x="6891120" y="5013360"/>
                <a:chExt cx="152280" cy="75960"/>
              </a:xfrm>
            </p:grpSpPr>
            <p:sp>
              <p:nvSpPr>
                <p:cNvPr id="56" name=""/>
                <p:cNvSpPr/>
                <p:nvPr/>
              </p:nvSpPr>
              <p:spPr>
                <a:xfrm>
                  <a:off x="6891120" y="505116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7043400" y="501336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6891120" y="501336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9" name=""/>
              <p:cNvSpPr/>
              <p:nvPr/>
            </p:nvSpPr>
            <p:spPr>
              <a:xfrm>
                <a:off x="6652440" y="508788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0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61" name="" descr=""/>
            <p:cNvPicPr/>
            <p:nvPr/>
          </p:nvPicPr>
          <p:blipFill>
            <a:blip r:embed="rId3"/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2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63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64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7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8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69" name="" descr=""/>
            <p:cNvPicPr/>
            <p:nvPr/>
          </p:nvPicPr>
          <p:blipFill>
            <a:blip r:embed="rId4"/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0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71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72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5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76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77" name="" descr=""/>
            <p:cNvPicPr/>
            <p:nvPr/>
          </p:nvPicPr>
          <p:blipFill>
            <a:blip r:embed="rId5">
              <a:lum bright="24000"/>
            </a:blip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8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79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80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3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84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85" name="" descr=""/>
            <p:cNvPicPr/>
            <p:nvPr/>
          </p:nvPicPr>
          <p:blipFill>
            <a:blip r:embed="rId6"/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6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87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88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1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92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93" name="" descr=""/>
            <p:cNvPicPr/>
            <p:nvPr/>
          </p:nvPicPr>
          <p:blipFill>
            <a:blip r:embed="rId7"/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4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95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96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9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0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101" name="" descr=""/>
            <p:cNvPicPr/>
            <p:nvPr/>
          </p:nvPicPr>
          <p:blipFill>
            <a:blip r:embed="rId8">
              <a:lum bright="24000"/>
            </a:blip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2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103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104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7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8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109" name="" descr=""/>
            <p:cNvPicPr/>
            <p:nvPr/>
          </p:nvPicPr>
          <p:blipFill>
            <a:blip r:embed="rId9"/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0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111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112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5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16" name=""/>
          <p:cNvGrpSpPr/>
          <p:nvPr/>
        </p:nvGrpSpPr>
        <p:grpSpPr>
          <a:xfrm>
            <a:off x="1778040" y="1314360"/>
            <a:ext cx="5533920" cy="4133520"/>
            <a:chOff x="1778040" y="1314360"/>
            <a:chExt cx="5533920" cy="4133520"/>
          </a:xfrm>
        </p:grpSpPr>
        <p:pic>
          <p:nvPicPr>
            <p:cNvPr id="117" name="" descr=""/>
            <p:cNvPicPr/>
            <p:nvPr/>
          </p:nvPicPr>
          <p:blipFill>
            <a:blip r:embed="rId10"/>
            <a:stretch/>
          </p:blipFill>
          <p:spPr>
            <a:xfrm>
              <a:off x="1778040" y="1314360"/>
              <a:ext cx="5533920" cy="413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8" name=""/>
            <p:cNvGrpSpPr/>
            <p:nvPr/>
          </p:nvGrpSpPr>
          <p:grpSpPr>
            <a:xfrm>
              <a:off x="6655680" y="5006880"/>
              <a:ext cx="609120" cy="366480"/>
              <a:chOff x="6655680" y="5006880"/>
              <a:chExt cx="609120" cy="366480"/>
            </a:xfrm>
          </p:grpSpPr>
          <p:grpSp>
            <p:nvGrpSpPr>
              <p:cNvPr id="119" name=""/>
              <p:cNvGrpSpPr/>
              <p:nvPr/>
            </p:nvGrpSpPr>
            <p:grpSpPr>
              <a:xfrm>
                <a:off x="6894360" y="5006880"/>
                <a:ext cx="152280" cy="75960"/>
                <a:chOff x="6894360" y="5006880"/>
                <a:chExt cx="152280" cy="75960"/>
              </a:xfrm>
            </p:grpSpPr>
            <p:sp>
              <p:nvSpPr>
                <p:cNvPr id="120" name=""/>
                <p:cNvSpPr/>
                <p:nvPr/>
              </p:nvSpPr>
              <p:spPr>
                <a:xfrm>
                  <a:off x="6894360" y="5044680"/>
                  <a:ext cx="1522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704664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6894360" y="5006880"/>
                  <a:ext cx="0" cy="7596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3" name=""/>
              <p:cNvSpPr/>
              <p:nvPr/>
            </p:nvSpPr>
            <p:spPr>
              <a:xfrm>
                <a:off x="6655680" y="5081400"/>
                <a:ext cx="6091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300" spc="-1" strike="noStrike">
                    <a:solidFill>
                      <a:srgbClr val="ffffff"/>
                    </a:solidFill>
                    <a:latin typeface="Times New Roman"/>
                    <a:ea typeface="宋体"/>
                  </a:rPr>
                  <a:t>10 µm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4T15:16:15Z</dcterms:created>
  <dc:creator>proteomics</dc:creator>
  <dc:description/>
  <dc:language>en-US</dc:language>
  <cp:lastModifiedBy>wu</cp:lastModifiedBy>
  <dcterms:modified xsi:type="dcterms:W3CDTF">2007-05-20T20:22:07Z</dcterms:modified>
  <cp:revision>4</cp:revision>
  <dc:subject/>
  <dc:title>Slide 1</dc:title>
</cp:coreProperties>
</file>